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9" r:id="rId2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81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3" autoAdjust="0"/>
    <p:restoredTop sz="94660"/>
  </p:normalViewPr>
  <p:slideViewPr>
    <p:cSldViewPr snapToGrid="0" showGuides="1">
      <p:cViewPr varScale="1">
        <p:scale>
          <a:sx n="103" d="100"/>
          <a:sy n="103" d="100"/>
        </p:scale>
        <p:origin x="798" y="102"/>
      </p:cViewPr>
      <p:guideLst>
        <p:guide orient="horz" pos="3181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EBD3E1-6326-EAEA-AA4E-CB5664E984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02D0526-7E61-4955-C031-9EA89C7562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DF2C1E-38EC-8B8A-A7BE-EC040CC8A6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AADFBC-C91F-5CBC-54B3-4C658984D5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52583A-2352-4C78-86BB-774E98FFE2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58537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EE30B9-C040-132F-A1C4-8172C28003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A03955B-6253-0D82-33E2-EDD1B7AB28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9A5B06-6F2A-5AE5-BE9C-DD07ECCCD6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FEE445-1621-FBC9-E792-43D7609863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2369B8-D6CE-27EA-7498-70B34AE5C0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816574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F880743-1CFB-AC71-338B-581B6772AD7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010A6E-5332-4B08-0A1D-0DC9340D06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1D51BD-84B4-7976-24EC-094010A8F0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331B07-82A2-E942-D06E-FFC5B0D4C3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AF6A76-8A1F-0688-EE6F-2078EAFE5A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755514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F3E397-79D5-30F9-A8C0-F3B86E15F7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9610C1-7A98-BF48-A2AF-683559E1A8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00C6C2-AA6B-EB49-2583-64B6A950F8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DCBB0F-A3C7-9429-880E-1FC64B1959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791E40-FF26-D932-0EF5-9DDB647766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2422116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73D8DF-71DA-8218-28D6-E7EC6AE785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1B982E-D9EE-5835-E4D2-350C5DAE5F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E7E71C-5258-791B-3B64-E2B907D766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4F21D1-DCBC-169D-670B-397A75146F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FD0D0E-E25F-538C-3CED-F7DB0DF359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740480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D48F06-69FF-335F-695D-069C1F7E31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8A1050-E907-ECD8-155C-B94F5451174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03AD79C-6A2F-E8B2-F807-B0ADDE505B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77B32F-B922-FC4C-493F-BEAC651157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9B2302-3A20-03B8-4459-5A6B28CCCE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B91015-9DED-EFBE-5779-FCAC1CB788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6364862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3F1416-A4CA-1D91-A003-DD2AAF4356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432463-0B34-A737-65BB-F6FCAC0A33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113B73-E643-3092-50C9-836C9273E4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A147ECC-A451-466E-6ECB-1BE0B4500B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7076EE5-C818-67D0-7AAB-5F69949C86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D4E11F5-A3FB-42D9-A9D0-EFE9095218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70E7305-6858-DBEE-881F-76F2350B17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0975E74-89A1-F5D2-9C87-2D7AC19DD2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721310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4F422E-8E1D-99B9-8B97-615EF683F8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240BCA1-6E04-5962-505B-0E17E5405D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616ACF3-E789-0CEA-3936-FD252725EC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7920E13-E437-C9B0-D852-7871D09420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36095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A46A43E-DC2B-F021-58DF-61A3C4743A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57B6230-23B2-2C7D-EF85-43A070D264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B6D0EF5-46BD-D13C-40C4-DAFB822B68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4708934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CEBB53-9C26-4294-175C-1D460F48F7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03EC4A-5007-1117-DB6C-A6FDF0C1980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1B1829-202B-854C-33F2-199B1F8804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CDE4F7-D23B-5599-8F0A-7F2F10EF1A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2A92CD-7C91-D174-09C5-DCC96EDDC5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A75C27-6ECB-2D3D-5FF3-899FB7237C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1240718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8417BF-3F53-8031-0BAB-23C8DE041D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9C1DF2B-D017-650A-D31A-5C0EA899399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2728D31-D4E1-C75A-3FC7-5C3FD85F98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22918E-FA99-6637-6D5E-D507AFDC5B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834CCB-EB1E-B7C4-EC23-60CCAECD90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CC1839-D199-4C5B-37FF-3EA45899E8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255112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A7C2DD5-AC70-7812-5B43-692C6DB307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DDEA4D-A887-84F0-E009-C3EDB043B3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696AF1-DFBC-6713-64CB-66907C7F6D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A10548-7A20-B0AA-D96C-22CF5C01CCC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8D20B0-C719-0828-4564-ACEF025D2E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2285805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B55C3A9-3571-4F4C-BF23-42A3E969D82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265" t="48808" r="42841" b="-286"/>
          <a:stretch/>
        </p:blipFill>
        <p:spPr bwMode="auto">
          <a:xfrm>
            <a:off x="3876261" y="3429000"/>
            <a:ext cx="4357693" cy="3197087"/>
          </a:xfrm>
          <a:prstGeom prst="rect">
            <a:avLst/>
          </a:prstGeom>
          <a:ln>
            <a:noFill/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93551316-11D0-4807-BB41-B71B6256B80C}"/>
              </a:ext>
            </a:extLst>
          </p:cNvPr>
          <p:cNvSpPr/>
          <p:nvPr/>
        </p:nvSpPr>
        <p:spPr>
          <a:xfrm>
            <a:off x="4801733" y="4534343"/>
            <a:ext cx="2820003" cy="7659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5C66C51-B034-4B08-8589-D3F054A3307F}"/>
              </a:ext>
            </a:extLst>
          </p:cNvPr>
          <p:cNvSpPr txBox="1"/>
          <p:nvPr/>
        </p:nvSpPr>
        <p:spPr>
          <a:xfrm>
            <a:off x="7950165" y="4872879"/>
            <a:ext cx="18181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-CASP3 (p17/p19)</a:t>
            </a:r>
            <a:endParaRPr lang="en-DE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4EEFCD7-341B-8FD0-59E3-C7E4BD91C62E}"/>
              </a:ext>
            </a:extLst>
          </p:cNvPr>
          <p:cNvSpPr txBox="1"/>
          <p:nvPr/>
        </p:nvSpPr>
        <p:spPr>
          <a:xfrm>
            <a:off x="998926" y="1031013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t 4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FA72B4A-FFC6-7D37-A863-D27855B1CA1D}"/>
              </a:ext>
            </a:extLst>
          </p:cNvPr>
          <p:cNvSpPr txBox="1"/>
          <p:nvPr/>
        </p:nvSpPr>
        <p:spPr>
          <a:xfrm rot="16200000">
            <a:off x="4799263" y="2737232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1AB5871-DD00-D8AA-55FE-A1DAB5200A8F}"/>
              </a:ext>
            </a:extLst>
          </p:cNvPr>
          <p:cNvSpPr txBox="1"/>
          <p:nvPr/>
        </p:nvSpPr>
        <p:spPr>
          <a:xfrm rot="16200000">
            <a:off x="5436920" y="1527494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moderate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20BC9DE-82FE-C111-846F-D96CB16B3C67}"/>
              </a:ext>
            </a:extLst>
          </p:cNvPr>
          <p:cNvSpPr txBox="1"/>
          <p:nvPr/>
        </p:nvSpPr>
        <p:spPr>
          <a:xfrm rot="16200000">
            <a:off x="4977380" y="2448611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4FBF1C3-B34C-4A84-2F25-36EC86EF338C}"/>
              </a:ext>
            </a:extLst>
          </p:cNvPr>
          <p:cNvSpPr txBox="1"/>
          <p:nvPr/>
        </p:nvSpPr>
        <p:spPr>
          <a:xfrm rot="16200000">
            <a:off x="5736669" y="2328237"/>
            <a:ext cx="13003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L-NG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27715A9-3691-E917-DFD1-7579DA96661D}"/>
              </a:ext>
            </a:extLst>
          </p:cNvPr>
          <p:cNvSpPr txBox="1"/>
          <p:nvPr/>
        </p:nvSpPr>
        <p:spPr>
          <a:xfrm rot="16200000">
            <a:off x="5455058" y="2501361"/>
            <a:ext cx="95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55583DA-202F-E6D1-E4A3-8D5B949E7D89}"/>
              </a:ext>
            </a:extLst>
          </p:cNvPr>
          <p:cNvSpPr txBox="1"/>
          <p:nvPr/>
        </p:nvSpPr>
        <p:spPr>
          <a:xfrm rot="16200000">
            <a:off x="5897766" y="1573751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high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ED1BA515-7088-1C7B-72DB-46C25E48542A}"/>
              </a:ext>
            </a:extLst>
          </p:cNvPr>
          <p:cNvCxnSpPr>
            <a:cxnSpLocks/>
          </p:cNvCxnSpPr>
          <p:nvPr/>
        </p:nvCxnSpPr>
        <p:spPr>
          <a:xfrm>
            <a:off x="4819956" y="3081245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76D78863-979A-1285-BB60-EBDF8B9EAC83}"/>
              </a:ext>
            </a:extLst>
          </p:cNvPr>
          <p:cNvCxnSpPr>
            <a:cxnSpLocks/>
          </p:cNvCxnSpPr>
          <p:nvPr/>
        </p:nvCxnSpPr>
        <p:spPr>
          <a:xfrm>
            <a:off x="5283782" y="3081245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E571CC5E-C24C-6E3C-673D-F28B653350D6}"/>
              </a:ext>
            </a:extLst>
          </p:cNvPr>
          <p:cNvCxnSpPr>
            <a:cxnSpLocks/>
          </p:cNvCxnSpPr>
          <p:nvPr/>
        </p:nvCxnSpPr>
        <p:spPr>
          <a:xfrm>
            <a:off x="5744627" y="3080996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C338F551-DC84-8E68-73C8-F6CC04EBABEB}"/>
              </a:ext>
            </a:extLst>
          </p:cNvPr>
          <p:cNvCxnSpPr>
            <a:cxnSpLocks/>
          </p:cNvCxnSpPr>
          <p:nvPr/>
        </p:nvCxnSpPr>
        <p:spPr>
          <a:xfrm>
            <a:off x="6199107" y="3080996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A5567644-7424-01DF-3D02-B1E293B88AA7}"/>
              </a:ext>
            </a:extLst>
          </p:cNvPr>
          <p:cNvCxnSpPr>
            <a:cxnSpLocks/>
          </p:cNvCxnSpPr>
          <p:nvPr/>
        </p:nvCxnSpPr>
        <p:spPr>
          <a:xfrm>
            <a:off x="6648756" y="3083411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8D475253-E7CD-68FB-53A8-5FD85B2A488B}"/>
              </a:ext>
            </a:extLst>
          </p:cNvPr>
          <p:cNvCxnSpPr>
            <a:cxnSpLocks/>
          </p:cNvCxnSpPr>
          <p:nvPr/>
        </p:nvCxnSpPr>
        <p:spPr>
          <a:xfrm>
            <a:off x="7105956" y="3080996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6E95F669-C754-9E04-3053-062C5BF6FBBA}"/>
              </a:ext>
            </a:extLst>
          </p:cNvPr>
          <p:cNvSpPr txBox="1"/>
          <p:nvPr/>
        </p:nvSpPr>
        <p:spPr>
          <a:xfrm>
            <a:off x="4229716" y="3116914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2C59D89-315C-D57A-4A1B-E59C2558BDF0}"/>
              </a:ext>
            </a:extLst>
          </p:cNvPr>
          <p:cNvSpPr txBox="1"/>
          <p:nvPr/>
        </p:nvSpPr>
        <p:spPr>
          <a:xfrm>
            <a:off x="3848911" y="3396381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mricasan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64B5C5C-966F-5144-14AC-1AE5981281B5}"/>
              </a:ext>
            </a:extLst>
          </p:cNvPr>
          <p:cNvSpPr txBox="1"/>
          <p:nvPr/>
        </p:nvSpPr>
        <p:spPr>
          <a:xfrm>
            <a:off x="4755351" y="3100188"/>
            <a:ext cx="28584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+    +    +    +    +   +    +   +     +    +    +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7A79755-9EF7-7E6B-E55C-7327EE21A4F9}"/>
              </a:ext>
            </a:extLst>
          </p:cNvPr>
          <p:cNvSpPr txBox="1"/>
          <p:nvPr/>
        </p:nvSpPr>
        <p:spPr>
          <a:xfrm>
            <a:off x="4755351" y="3349574"/>
            <a:ext cx="28584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-    +    -    +    -   +    -   +     -    +    -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5A574FFF-A551-4641-88C5-9C3206A05EE2}"/>
              </a:ext>
            </a:extLst>
          </p:cNvPr>
          <p:cNvCxnSpPr>
            <a:cxnSpLocks/>
          </p:cNvCxnSpPr>
          <p:nvPr/>
        </p:nvCxnSpPr>
        <p:spPr>
          <a:xfrm>
            <a:off x="4371479" y="4339260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36">
            <a:extLst>
              <a:ext uri="{FF2B5EF4-FFF2-40B4-BE49-F238E27FC236}">
                <a16:creationId xmlns:a16="http://schemas.microsoft.com/office/drawing/2014/main" id="{B6D0D383-1505-487F-82B9-B59E6F78A4FF}"/>
              </a:ext>
            </a:extLst>
          </p:cNvPr>
          <p:cNvSpPr txBox="1"/>
          <p:nvPr/>
        </p:nvSpPr>
        <p:spPr>
          <a:xfrm>
            <a:off x="4043093" y="419719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F9B40CB1-81A9-45A0-B4CD-F5B29B9AF4E7}"/>
              </a:ext>
            </a:extLst>
          </p:cNvPr>
          <p:cNvCxnSpPr>
            <a:cxnSpLocks/>
          </p:cNvCxnSpPr>
          <p:nvPr/>
        </p:nvCxnSpPr>
        <p:spPr>
          <a:xfrm>
            <a:off x="4373293" y="4548677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Box 38">
            <a:extLst>
              <a:ext uri="{FF2B5EF4-FFF2-40B4-BE49-F238E27FC236}">
                <a16:creationId xmlns:a16="http://schemas.microsoft.com/office/drawing/2014/main" id="{1F2CDE62-3CD6-4FD1-BF2A-3EF20FAFD791}"/>
              </a:ext>
            </a:extLst>
          </p:cNvPr>
          <p:cNvSpPr txBox="1"/>
          <p:nvPr/>
        </p:nvSpPr>
        <p:spPr>
          <a:xfrm>
            <a:off x="4044907" y="440660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F9EAF9DA-BF25-41EE-8C51-075774D50D8A}"/>
              </a:ext>
            </a:extLst>
          </p:cNvPr>
          <p:cNvCxnSpPr>
            <a:cxnSpLocks/>
          </p:cNvCxnSpPr>
          <p:nvPr/>
        </p:nvCxnSpPr>
        <p:spPr>
          <a:xfrm>
            <a:off x="4372762" y="4065124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40">
            <a:extLst>
              <a:ext uri="{FF2B5EF4-FFF2-40B4-BE49-F238E27FC236}">
                <a16:creationId xmlns:a16="http://schemas.microsoft.com/office/drawing/2014/main" id="{70309426-856D-4AA9-A0E1-A64FA23EA01F}"/>
              </a:ext>
            </a:extLst>
          </p:cNvPr>
          <p:cNvSpPr txBox="1"/>
          <p:nvPr/>
        </p:nvSpPr>
        <p:spPr>
          <a:xfrm>
            <a:off x="4044376" y="392305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564853D1-D2AA-4555-9232-8F4B30CE5274}"/>
              </a:ext>
            </a:extLst>
          </p:cNvPr>
          <p:cNvCxnSpPr>
            <a:cxnSpLocks/>
          </p:cNvCxnSpPr>
          <p:nvPr/>
        </p:nvCxnSpPr>
        <p:spPr>
          <a:xfrm>
            <a:off x="4371288" y="3892833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Box 42">
            <a:extLst>
              <a:ext uri="{FF2B5EF4-FFF2-40B4-BE49-F238E27FC236}">
                <a16:creationId xmlns:a16="http://schemas.microsoft.com/office/drawing/2014/main" id="{44A5D88D-F615-4853-BFC0-329F609A7F01}"/>
              </a:ext>
            </a:extLst>
          </p:cNvPr>
          <p:cNvSpPr txBox="1"/>
          <p:nvPr/>
        </p:nvSpPr>
        <p:spPr>
          <a:xfrm>
            <a:off x="4042902" y="374399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ED009B97-457D-4873-A180-87F76ED0D6D6}"/>
              </a:ext>
            </a:extLst>
          </p:cNvPr>
          <p:cNvCxnSpPr>
            <a:cxnSpLocks/>
          </p:cNvCxnSpPr>
          <p:nvPr/>
        </p:nvCxnSpPr>
        <p:spPr>
          <a:xfrm>
            <a:off x="4371479" y="5053595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" name="TextBox 38">
            <a:extLst>
              <a:ext uri="{FF2B5EF4-FFF2-40B4-BE49-F238E27FC236}">
                <a16:creationId xmlns:a16="http://schemas.microsoft.com/office/drawing/2014/main" id="{F43B81AB-3B63-411F-8B44-CF7662B6A8A3}"/>
              </a:ext>
            </a:extLst>
          </p:cNvPr>
          <p:cNvSpPr txBox="1"/>
          <p:nvPr/>
        </p:nvSpPr>
        <p:spPr>
          <a:xfrm>
            <a:off x="4043093" y="491152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122297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7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smin Carvalho Schäfer</dc:creator>
  <cp:lastModifiedBy>mnagata</cp:lastModifiedBy>
  <cp:revision>10</cp:revision>
  <dcterms:created xsi:type="dcterms:W3CDTF">2024-08-13T14:46:47Z</dcterms:created>
  <dcterms:modified xsi:type="dcterms:W3CDTF">2024-08-14T22:13:23Z</dcterms:modified>
</cp:coreProperties>
</file>